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5C6CAC5-A05E-461B-8AFA-DDDBCD9BD9C6}" v="12" dt="2025-03-18T10:20:49.9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8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isha Begum Samad" userId="6bf00af3-bd88-4dab-ba84-d805e4686431" providerId="ADAL" clId="{15C6CAC5-A05E-461B-8AFA-DDDBCD9BD9C6}"/>
    <pc:docChg chg="custSel addSld delSld modSld">
      <pc:chgData name="Manisha Begum Samad" userId="6bf00af3-bd88-4dab-ba84-d805e4686431" providerId="ADAL" clId="{15C6CAC5-A05E-461B-8AFA-DDDBCD9BD9C6}" dt="2025-03-18T10:27:57.635" v="606" actId="478"/>
      <pc:docMkLst>
        <pc:docMk/>
      </pc:docMkLst>
      <pc:sldChg chg="modSp del mod modNotesTx">
        <pc:chgData name="Manisha Begum Samad" userId="6bf00af3-bd88-4dab-ba84-d805e4686431" providerId="ADAL" clId="{15C6CAC5-A05E-461B-8AFA-DDDBCD9BD9C6}" dt="2025-03-18T10:22:00.781" v="595" actId="2696"/>
        <pc:sldMkLst>
          <pc:docMk/>
          <pc:sldMk cId="3143720724" sldId="282"/>
        </pc:sldMkLst>
        <pc:spChg chg="mod">
          <ac:chgData name="Manisha Begum Samad" userId="6bf00af3-bd88-4dab-ba84-d805e4686431" providerId="ADAL" clId="{15C6CAC5-A05E-461B-8AFA-DDDBCD9BD9C6}" dt="2025-03-18T10:17:59.181" v="75" actId="1076"/>
          <ac:spMkLst>
            <pc:docMk/>
            <pc:sldMk cId="3143720724" sldId="282"/>
            <ac:spMk id="2" creationId="{F10C13F9-573C-0B54-5839-7996ECD4DD7C}"/>
          </ac:spMkLst>
        </pc:spChg>
        <pc:spChg chg="mod">
          <ac:chgData name="Manisha Begum Samad" userId="6bf00af3-bd88-4dab-ba84-d805e4686431" providerId="ADAL" clId="{15C6CAC5-A05E-461B-8AFA-DDDBCD9BD9C6}" dt="2025-03-18T10:10:01.845" v="3" actId="1076"/>
          <ac:spMkLst>
            <pc:docMk/>
            <pc:sldMk cId="3143720724" sldId="282"/>
            <ac:spMk id="92" creationId="{5BA59082-B3CB-C347-B5ED-3E7FDCC933E9}"/>
          </ac:spMkLst>
        </pc:spChg>
      </pc:sldChg>
      <pc:sldChg chg="addSp delSp modSp add mod">
        <pc:chgData name="Manisha Begum Samad" userId="6bf00af3-bd88-4dab-ba84-d805e4686431" providerId="ADAL" clId="{15C6CAC5-A05E-461B-8AFA-DDDBCD9BD9C6}" dt="2025-03-18T10:27:57.635" v="606" actId="478"/>
        <pc:sldMkLst>
          <pc:docMk/>
          <pc:sldMk cId="660027975" sldId="283"/>
        </pc:sldMkLst>
        <pc:spChg chg="del mod">
          <ac:chgData name="Manisha Begum Samad" userId="6bf00af3-bd88-4dab-ba84-d805e4686431" providerId="ADAL" clId="{15C6CAC5-A05E-461B-8AFA-DDDBCD9BD9C6}" dt="2025-03-18T10:20:13.872" v="341" actId="478"/>
          <ac:spMkLst>
            <pc:docMk/>
            <pc:sldMk cId="660027975" sldId="283"/>
            <ac:spMk id="2" creationId="{6453A305-10A3-5A10-5DD5-0F618ED9FCB1}"/>
          </ac:spMkLst>
        </pc:spChg>
        <pc:spChg chg="add mod">
          <ac:chgData name="Manisha Begum Samad" userId="6bf00af3-bd88-4dab-ba84-d805e4686431" providerId="ADAL" clId="{15C6CAC5-A05E-461B-8AFA-DDDBCD9BD9C6}" dt="2025-03-18T10:21:36.516" v="593" actId="1076"/>
          <ac:spMkLst>
            <pc:docMk/>
            <pc:sldMk cId="660027975" sldId="283"/>
            <ac:spMk id="6" creationId="{F2175D21-53AA-1660-C8E1-853F9B226447}"/>
          </ac:spMkLst>
        </pc:spChg>
        <pc:spChg chg="add mod">
          <ac:chgData name="Manisha Begum Samad" userId="6bf00af3-bd88-4dab-ba84-d805e4686431" providerId="ADAL" clId="{15C6CAC5-A05E-461B-8AFA-DDDBCD9BD9C6}" dt="2025-03-18T10:21:51.988" v="594" actId="1076"/>
          <ac:spMkLst>
            <pc:docMk/>
            <pc:sldMk cId="660027975" sldId="283"/>
            <ac:spMk id="8" creationId="{B977E841-D9A2-EE94-5FF5-9318090B1F1A}"/>
          </ac:spMkLst>
        </pc:spChg>
        <pc:spChg chg="add mod">
          <ac:chgData name="Manisha Begum Samad" userId="6bf00af3-bd88-4dab-ba84-d805e4686431" providerId="ADAL" clId="{15C6CAC5-A05E-461B-8AFA-DDDBCD9BD9C6}" dt="2025-03-18T10:21:51.988" v="594" actId="1076"/>
          <ac:spMkLst>
            <pc:docMk/>
            <pc:sldMk cId="660027975" sldId="283"/>
            <ac:spMk id="9" creationId="{18AF6D23-8B1F-5F5E-9BD1-3E936FF2E510}"/>
          </ac:spMkLst>
        </pc:spChg>
        <pc:spChg chg="add del mod">
          <ac:chgData name="Manisha Begum Samad" userId="6bf00af3-bd88-4dab-ba84-d805e4686431" providerId="ADAL" clId="{15C6CAC5-A05E-461B-8AFA-DDDBCD9BD9C6}" dt="2025-03-18T10:20:02.157" v="335" actId="478"/>
          <ac:spMkLst>
            <pc:docMk/>
            <pc:sldMk cId="660027975" sldId="283"/>
            <ac:spMk id="12" creationId="{3AD7DFBF-6B33-9843-5B4F-4291CE80F413}"/>
          </ac:spMkLst>
        </pc:spChg>
        <pc:spChg chg="add mod">
          <ac:chgData name="Manisha Begum Samad" userId="6bf00af3-bd88-4dab-ba84-d805e4686431" providerId="ADAL" clId="{15C6CAC5-A05E-461B-8AFA-DDDBCD9BD9C6}" dt="2025-03-18T10:21:24.291" v="592" actId="1035"/>
          <ac:spMkLst>
            <pc:docMk/>
            <pc:sldMk cId="660027975" sldId="283"/>
            <ac:spMk id="13" creationId="{285FDACD-C13C-D586-C524-AE6B88020192}"/>
          </ac:spMkLst>
        </pc:spChg>
        <pc:spChg chg="add del mod">
          <ac:chgData name="Manisha Begum Samad" userId="6bf00af3-bd88-4dab-ba84-d805e4686431" providerId="ADAL" clId="{15C6CAC5-A05E-461B-8AFA-DDDBCD9BD9C6}" dt="2025-03-18T10:20:11.230" v="340" actId="478"/>
          <ac:spMkLst>
            <pc:docMk/>
            <pc:sldMk cId="660027975" sldId="283"/>
            <ac:spMk id="15" creationId="{B21E1681-F128-694B-9779-79C4A9A785B6}"/>
          </ac:spMkLst>
        </pc:spChg>
        <pc:spChg chg="add del mod">
          <ac:chgData name="Manisha Begum Samad" userId="6bf00af3-bd88-4dab-ba84-d805e4686431" providerId="ADAL" clId="{15C6CAC5-A05E-461B-8AFA-DDDBCD9BD9C6}" dt="2025-03-18T10:20:08.575" v="338" actId="478"/>
          <ac:spMkLst>
            <pc:docMk/>
            <pc:sldMk cId="660027975" sldId="283"/>
            <ac:spMk id="16" creationId="{236F388C-AC46-2D9A-99ED-038001B47607}"/>
          </ac:spMkLst>
        </pc:spChg>
        <pc:spChg chg="add mod">
          <ac:chgData name="Manisha Begum Samad" userId="6bf00af3-bd88-4dab-ba84-d805e4686431" providerId="ADAL" clId="{15C6CAC5-A05E-461B-8AFA-DDDBCD9BD9C6}" dt="2025-03-18T10:21:24.291" v="592" actId="1035"/>
          <ac:spMkLst>
            <pc:docMk/>
            <pc:sldMk cId="660027975" sldId="283"/>
            <ac:spMk id="17" creationId="{3BDA3DA6-1852-F7DD-2540-6011144068BB}"/>
          </ac:spMkLst>
        </pc:spChg>
        <pc:spChg chg="add del mod">
          <ac:chgData name="Manisha Begum Samad" userId="6bf00af3-bd88-4dab-ba84-d805e4686431" providerId="ADAL" clId="{15C6CAC5-A05E-461B-8AFA-DDDBCD9BD9C6}" dt="2025-03-18T10:27:57.635" v="606" actId="478"/>
          <ac:spMkLst>
            <pc:docMk/>
            <pc:sldMk cId="660027975" sldId="283"/>
            <ac:spMk id="18" creationId="{63D5D26A-ED51-3BFB-DE7B-81C1510176C3}"/>
          </ac:spMkLst>
        </pc:spChg>
        <pc:spChg chg="add mod">
          <ac:chgData name="Manisha Begum Samad" userId="6bf00af3-bd88-4dab-ba84-d805e4686431" providerId="ADAL" clId="{15C6CAC5-A05E-461B-8AFA-DDDBCD9BD9C6}" dt="2025-03-18T10:21:24.291" v="592" actId="1035"/>
          <ac:spMkLst>
            <pc:docMk/>
            <pc:sldMk cId="660027975" sldId="283"/>
            <ac:spMk id="19" creationId="{00F33429-06E2-0165-B08B-D8C7E664B345}"/>
          </ac:spMkLst>
        </pc:spChg>
        <pc:spChg chg="del">
          <ac:chgData name="Manisha Begum Samad" userId="6bf00af3-bd88-4dab-ba84-d805e4686431" providerId="ADAL" clId="{15C6CAC5-A05E-461B-8AFA-DDDBCD9BD9C6}" dt="2025-03-18T10:17:46.844" v="74" actId="478"/>
          <ac:spMkLst>
            <pc:docMk/>
            <pc:sldMk cId="660027975" sldId="283"/>
            <ac:spMk id="86" creationId="{E350CDC0-E3E8-F365-69D2-2ECAEA11A062}"/>
          </ac:spMkLst>
        </pc:spChg>
        <pc:spChg chg="del mod">
          <ac:chgData name="Manisha Begum Samad" userId="6bf00af3-bd88-4dab-ba84-d805e4686431" providerId="ADAL" clId="{15C6CAC5-A05E-461B-8AFA-DDDBCD9BD9C6}" dt="2025-03-18T10:14:25.139" v="34" actId="21"/>
          <ac:spMkLst>
            <pc:docMk/>
            <pc:sldMk cId="660027975" sldId="283"/>
            <ac:spMk id="87" creationId="{285FDACD-C13C-D586-C524-AE6B88020192}"/>
          </ac:spMkLst>
        </pc:spChg>
        <pc:spChg chg="del">
          <ac:chgData name="Manisha Begum Samad" userId="6bf00af3-bd88-4dab-ba84-d805e4686431" providerId="ADAL" clId="{15C6CAC5-A05E-461B-8AFA-DDDBCD9BD9C6}" dt="2025-03-18T10:15:41.490" v="43" actId="21"/>
          <ac:spMkLst>
            <pc:docMk/>
            <pc:sldMk cId="660027975" sldId="283"/>
            <ac:spMk id="88" creationId="{63D5D26A-ED51-3BFB-DE7B-81C1510176C3}"/>
          </ac:spMkLst>
        </pc:spChg>
        <pc:spChg chg="del">
          <ac:chgData name="Manisha Begum Samad" userId="6bf00af3-bd88-4dab-ba84-d805e4686431" providerId="ADAL" clId="{15C6CAC5-A05E-461B-8AFA-DDDBCD9BD9C6}" dt="2025-03-18T10:17:43.864" v="73" actId="478"/>
          <ac:spMkLst>
            <pc:docMk/>
            <pc:sldMk cId="660027975" sldId="283"/>
            <ac:spMk id="92" creationId="{31605E84-E499-A157-8EE6-64B6C00C0241}"/>
          </ac:spMkLst>
        </pc:spChg>
        <pc:spChg chg="del">
          <ac:chgData name="Manisha Begum Samad" userId="6bf00af3-bd88-4dab-ba84-d805e4686431" providerId="ADAL" clId="{15C6CAC5-A05E-461B-8AFA-DDDBCD9BD9C6}" dt="2025-03-18T10:15:38.355" v="42" actId="478"/>
          <ac:spMkLst>
            <pc:docMk/>
            <pc:sldMk cId="660027975" sldId="283"/>
            <ac:spMk id="94" creationId="{AEFD417F-46BC-3099-4749-5422EF8D3DC0}"/>
          </ac:spMkLst>
        </pc:spChg>
        <pc:spChg chg="del mod">
          <ac:chgData name="Manisha Begum Samad" userId="6bf00af3-bd88-4dab-ba84-d805e4686431" providerId="ADAL" clId="{15C6CAC5-A05E-461B-8AFA-DDDBCD9BD9C6}" dt="2025-03-18T10:15:37.293" v="41" actId="478"/>
          <ac:spMkLst>
            <pc:docMk/>
            <pc:sldMk cId="660027975" sldId="283"/>
            <ac:spMk id="95" creationId="{ED6407BB-48F8-2B0E-B9F1-F2A8B5DCD963}"/>
          </ac:spMkLst>
        </pc:spChg>
        <pc:spChg chg="mod">
          <ac:chgData name="Manisha Begum Samad" userId="6bf00af3-bd88-4dab-ba84-d805e4686431" providerId="ADAL" clId="{15C6CAC5-A05E-461B-8AFA-DDDBCD9BD9C6}" dt="2025-03-18T10:26:54.194" v="604" actId="1038"/>
          <ac:spMkLst>
            <pc:docMk/>
            <pc:sldMk cId="660027975" sldId="283"/>
            <ac:spMk id="124" creationId="{14092EA3-6B66-6854-03A0-13C976FCAA7B}"/>
          </ac:spMkLst>
        </pc:spChg>
        <pc:spChg chg="mod">
          <ac:chgData name="Manisha Begum Samad" userId="6bf00af3-bd88-4dab-ba84-d805e4686431" providerId="ADAL" clId="{15C6CAC5-A05E-461B-8AFA-DDDBCD9BD9C6}" dt="2025-03-18T10:26:54.194" v="604" actId="1038"/>
          <ac:spMkLst>
            <pc:docMk/>
            <pc:sldMk cId="660027975" sldId="283"/>
            <ac:spMk id="130" creationId="{B549E2C9-B157-B993-706A-78119B09EAEC}"/>
          </ac:spMkLst>
        </pc:spChg>
        <pc:picChg chg="del mod">
          <ac:chgData name="Manisha Begum Samad" userId="6bf00af3-bd88-4dab-ba84-d805e4686431" providerId="ADAL" clId="{15C6CAC5-A05E-461B-8AFA-DDDBCD9BD9C6}" dt="2025-03-18T10:13:06.642" v="16" actId="21"/>
          <ac:picMkLst>
            <pc:docMk/>
            <pc:sldMk cId="660027975" sldId="283"/>
            <ac:picMk id="4" creationId="{849EB5A9-D8A0-4AEA-C22D-07B0F32616A7}"/>
          </ac:picMkLst>
        </pc:picChg>
        <pc:picChg chg="mod">
          <ac:chgData name="Manisha Begum Samad" userId="6bf00af3-bd88-4dab-ba84-d805e4686431" providerId="ADAL" clId="{15C6CAC5-A05E-461B-8AFA-DDDBCD9BD9C6}" dt="2025-03-18T10:26:31.890" v="598" actId="1076"/>
          <ac:picMkLst>
            <pc:docMk/>
            <pc:sldMk cId="660027975" sldId="283"/>
            <ac:picMk id="5" creationId="{7D91F181-150C-5B08-E95B-15658FA85D96}"/>
          </ac:picMkLst>
        </pc:picChg>
        <pc:picChg chg="mod">
          <ac:chgData name="Manisha Begum Samad" userId="6bf00af3-bd88-4dab-ba84-d805e4686431" providerId="ADAL" clId="{15C6CAC5-A05E-461B-8AFA-DDDBCD9BD9C6}" dt="2025-03-18T10:26:24.211" v="597" actId="1076"/>
          <ac:picMkLst>
            <pc:docMk/>
            <pc:sldMk cId="660027975" sldId="283"/>
            <ac:picMk id="7" creationId="{FFC6D7DB-CD40-B287-3591-8F354171DADF}"/>
          </ac:picMkLst>
        </pc:picChg>
        <pc:picChg chg="add mod">
          <ac:chgData name="Manisha Begum Samad" userId="6bf00af3-bd88-4dab-ba84-d805e4686431" providerId="ADAL" clId="{15C6CAC5-A05E-461B-8AFA-DDDBCD9BD9C6}" dt="2025-03-18T10:21:24.291" v="592" actId="1035"/>
          <ac:picMkLst>
            <pc:docMk/>
            <pc:sldMk cId="660027975" sldId="283"/>
            <ac:picMk id="11" creationId="{849EB5A9-D8A0-4AEA-C22D-07B0F32616A7}"/>
          </ac:picMkLst>
        </pc:picChg>
      </pc:sldChg>
      <pc:sldChg chg="addSp delSp modSp add del mod">
        <pc:chgData name="Manisha Begum Samad" userId="6bf00af3-bd88-4dab-ba84-d805e4686431" providerId="ADAL" clId="{15C6CAC5-A05E-461B-8AFA-DDDBCD9BD9C6}" dt="2025-03-18T10:22:05.928" v="596" actId="2696"/>
        <pc:sldMkLst>
          <pc:docMk/>
          <pc:sldMk cId="1216019506" sldId="284"/>
        </pc:sldMkLst>
        <pc:spChg chg="del">
          <ac:chgData name="Manisha Begum Samad" userId="6bf00af3-bd88-4dab-ba84-d805e4686431" providerId="ADAL" clId="{15C6CAC5-A05E-461B-8AFA-DDDBCD9BD9C6}" dt="2025-03-18T10:13:56.683" v="29" actId="478"/>
          <ac:spMkLst>
            <pc:docMk/>
            <pc:sldMk cId="1216019506" sldId="284"/>
            <ac:spMk id="2" creationId="{F97B046F-5271-6263-1321-5E05170F51FA}"/>
          </ac:spMkLst>
        </pc:spChg>
        <pc:spChg chg="del">
          <ac:chgData name="Manisha Begum Samad" userId="6bf00af3-bd88-4dab-ba84-d805e4686431" providerId="ADAL" clId="{15C6CAC5-A05E-461B-8AFA-DDDBCD9BD9C6}" dt="2025-03-18T10:13:59.580" v="30" actId="478"/>
          <ac:spMkLst>
            <pc:docMk/>
            <pc:sldMk cId="1216019506" sldId="284"/>
            <ac:spMk id="3" creationId="{2F3F0B2F-FE39-F041-A58B-96AFF718C216}"/>
          </ac:spMkLst>
        </pc:spChg>
        <pc:spChg chg="add del mod">
          <ac:chgData name="Manisha Begum Samad" userId="6bf00af3-bd88-4dab-ba84-d805e4686431" providerId="ADAL" clId="{15C6CAC5-A05E-461B-8AFA-DDDBCD9BD9C6}" dt="2025-03-18T10:20:46.429" v="354" actId="21"/>
          <ac:spMkLst>
            <pc:docMk/>
            <pc:sldMk cId="1216019506" sldId="284"/>
            <ac:spMk id="6" creationId="{285FDACD-C13C-D586-C524-AE6B88020192}"/>
          </ac:spMkLst>
        </pc:spChg>
        <pc:spChg chg="add del mod">
          <ac:chgData name="Manisha Begum Samad" userId="6bf00af3-bd88-4dab-ba84-d805e4686431" providerId="ADAL" clId="{15C6CAC5-A05E-461B-8AFA-DDDBCD9BD9C6}" dt="2025-03-18T10:20:46.429" v="354" actId="21"/>
          <ac:spMkLst>
            <pc:docMk/>
            <pc:sldMk cId="1216019506" sldId="284"/>
            <ac:spMk id="8" creationId="{3BDA3DA6-1852-F7DD-2540-6011144068BB}"/>
          </ac:spMkLst>
        </pc:spChg>
        <pc:spChg chg="add del mod">
          <ac:chgData name="Manisha Begum Samad" userId="6bf00af3-bd88-4dab-ba84-d805e4686431" providerId="ADAL" clId="{15C6CAC5-A05E-461B-8AFA-DDDBCD9BD9C6}" dt="2025-03-18T10:20:46.429" v="354" actId="21"/>
          <ac:spMkLst>
            <pc:docMk/>
            <pc:sldMk cId="1216019506" sldId="284"/>
            <ac:spMk id="9" creationId="{63D5D26A-ED51-3BFB-DE7B-81C1510176C3}"/>
          </ac:spMkLst>
        </pc:spChg>
        <pc:spChg chg="del mod">
          <ac:chgData name="Manisha Begum Samad" userId="6bf00af3-bd88-4dab-ba84-d805e4686431" providerId="ADAL" clId="{15C6CAC5-A05E-461B-8AFA-DDDBCD9BD9C6}" dt="2025-03-18T10:13:34.587" v="21"/>
          <ac:spMkLst>
            <pc:docMk/>
            <pc:sldMk cId="1216019506" sldId="284"/>
            <ac:spMk id="10" creationId="{C0E9D203-45DC-BBB7-60EF-445B5AFEF732}"/>
          </ac:spMkLst>
        </pc:spChg>
        <pc:spChg chg="add del mod">
          <ac:chgData name="Manisha Begum Samad" userId="6bf00af3-bd88-4dab-ba84-d805e4686431" providerId="ADAL" clId="{15C6CAC5-A05E-461B-8AFA-DDDBCD9BD9C6}" dt="2025-03-18T10:20:46.429" v="354" actId="21"/>
          <ac:spMkLst>
            <pc:docMk/>
            <pc:sldMk cId="1216019506" sldId="284"/>
            <ac:spMk id="11" creationId="{00F33429-06E2-0165-B08B-D8C7E664B345}"/>
          </ac:spMkLst>
        </pc:spChg>
        <pc:spChg chg="add del mod">
          <ac:chgData name="Manisha Begum Samad" userId="6bf00af3-bd88-4dab-ba84-d805e4686431" providerId="ADAL" clId="{15C6CAC5-A05E-461B-8AFA-DDDBCD9BD9C6}" dt="2025-03-18T10:19:19.422" v="126" actId="21"/>
          <ac:spMkLst>
            <pc:docMk/>
            <pc:sldMk cId="1216019506" sldId="284"/>
            <ac:spMk id="12" creationId="{3AD7DFBF-6B33-9843-5B4F-4291CE80F413}"/>
          </ac:spMkLst>
        </pc:spChg>
        <pc:spChg chg="add mod">
          <ac:chgData name="Manisha Begum Samad" userId="6bf00af3-bd88-4dab-ba84-d805e4686431" providerId="ADAL" clId="{15C6CAC5-A05E-461B-8AFA-DDDBCD9BD9C6}" dt="2025-03-18T10:18:12.981" v="76"/>
          <ac:spMkLst>
            <pc:docMk/>
            <pc:sldMk cId="1216019506" sldId="284"/>
            <ac:spMk id="13" creationId="{9631DB20-A63E-B68B-CFC5-73D2067F5AB3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4" creationId="{6F248402-D97B-6FA6-B06B-9450771C7341}"/>
          </ac:spMkLst>
        </pc:spChg>
        <pc:spChg chg="add del mod">
          <ac:chgData name="Manisha Begum Samad" userId="6bf00af3-bd88-4dab-ba84-d805e4686431" providerId="ADAL" clId="{15C6CAC5-A05E-461B-8AFA-DDDBCD9BD9C6}" dt="2025-03-18T10:19:19.422" v="126" actId="21"/>
          <ac:spMkLst>
            <pc:docMk/>
            <pc:sldMk cId="1216019506" sldId="284"/>
            <ac:spMk id="15" creationId="{B21E1681-F128-694B-9779-79C4A9A785B6}"/>
          </ac:spMkLst>
        </pc:spChg>
        <pc:spChg chg="add del mod">
          <ac:chgData name="Manisha Begum Samad" userId="6bf00af3-bd88-4dab-ba84-d805e4686431" providerId="ADAL" clId="{15C6CAC5-A05E-461B-8AFA-DDDBCD9BD9C6}" dt="2025-03-18T10:19:19.422" v="126" actId="21"/>
          <ac:spMkLst>
            <pc:docMk/>
            <pc:sldMk cId="1216019506" sldId="284"/>
            <ac:spMk id="16" creationId="{236F388C-AC46-2D9A-99ED-038001B47607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73" creationId="{4DC998F4-7972-F1FE-DCA8-CE0B782584E8}"/>
          </ac:spMkLst>
        </pc:spChg>
        <pc:spChg chg="del">
          <ac:chgData name="Manisha Begum Samad" userId="6bf00af3-bd88-4dab-ba84-d805e4686431" providerId="ADAL" clId="{15C6CAC5-A05E-461B-8AFA-DDDBCD9BD9C6}" dt="2025-03-18T10:13:52.007" v="26" actId="478"/>
          <ac:spMkLst>
            <pc:docMk/>
            <pc:sldMk cId="1216019506" sldId="284"/>
            <ac:spMk id="86" creationId="{8D77D10E-5464-C25C-1F3B-504D64A7192D}"/>
          </ac:spMkLst>
        </pc:spChg>
        <pc:spChg chg="del">
          <ac:chgData name="Manisha Begum Samad" userId="6bf00af3-bd88-4dab-ba84-d805e4686431" providerId="ADAL" clId="{15C6CAC5-A05E-461B-8AFA-DDDBCD9BD9C6}" dt="2025-03-18T10:13:54.798" v="28" actId="478"/>
          <ac:spMkLst>
            <pc:docMk/>
            <pc:sldMk cId="1216019506" sldId="284"/>
            <ac:spMk id="87" creationId="{97F94922-8A37-FEA2-629D-FE0B4E2A461E}"/>
          </ac:spMkLst>
        </pc:spChg>
        <pc:spChg chg="del">
          <ac:chgData name="Manisha Begum Samad" userId="6bf00af3-bd88-4dab-ba84-d805e4686431" providerId="ADAL" clId="{15C6CAC5-A05E-461B-8AFA-DDDBCD9BD9C6}" dt="2025-03-18T10:13:50.190" v="25" actId="478"/>
          <ac:spMkLst>
            <pc:docMk/>
            <pc:sldMk cId="1216019506" sldId="284"/>
            <ac:spMk id="88" creationId="{E260D460-8A72-04D3-AEE7-A63236EA3FF8}"/>
          </ac:spMkLst>
        </pc:spChg>
        <pc:spChg chg="del">
          <ac:chgData name="Manisha Begum Samad" userId="6bf00af3-bd88-4dab-ba84-d805e4686431" providerId="ADAL" clId="{15C6CAC5-A05E-461B-8AFA-DDDBCD9BD9C6}" dt="2025-03-18T10:13:53.109" v="27" actId="478"/>
          <ac:spMkLst>
            <pc:docMk/>
            <pc:sldMk cId="1216019506" sldId="284"/>
            <ac:spMk id="92" creationId="{556A29D1-4468-C8C2-3431-5003FD78F217}"/>
          </ac:spMkLst>
        </pc:spChg>
        <pc:spChg chg="del">
          <ac:chgData name="Manisha Begum Samad" userId="6bf00af3-bd88-4dab-ba84-d805e4686431" providerId="ADAL" clId="{15C6CAC5-A05E-461B-8AFA-DDDBCD9BD9C6}" dt="2025-03-18T10:13:46.726" v="23" actId="478"/>
          <ac:spMkLst>
            <pc:docMk/>
            <pc:sldMk cId="1216019506" sldId="284"/>
            <ac:spMk id="94" creationId="{0242267C-02DC-C34F-859B-F1FFB7A5E50E}"/>
          </ac:spMkLst>
        </pc:spChg>
        <pc:spChg chg="del">
          <ac:chgData name="Manisha Begum Samad" userId="6bf00af3-bd88-4dab-ba84-d805e4686431" providerId="ADAL" clId="{15C6CAC5-A05E-461B-8AFA-DDDBCD9BD9C6}" dt="2025-03-18T10:13:48.656" v="24" actId="478"/>
          <ac:spMkLst>
            <pc:docMk/>
            <pc:sldMk cId="1216019506" sldId="284"/>
            <ac:spMk id="95" creationId="{6838CA4F-79E4-4356-B6BD-2A2872FB2450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02" creationId="{5FB4BDD8-2513-FFA0-FDAB-3C90D4CFE265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04" creationId="{C5C5F43B-406A-CDC9-7868-0A0127683A35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06" creationId="{EBE5C1AD-1794-923C-CDEE-15DE6156F35A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15" creationId="{D2D8EC34-0F9E-AA72-79AC-DA6B5ED83184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23" creationId="{937DEFB8-5573-B9FF-B12F-06731D215B57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24" creationId="{17392A32-DBFC-3092-2D66-956A9C53B544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29" creationId="{1E793E29-302B-F6F5-973A-01513B13D23B}"/>
          </ac:spMkLst>
        </pc:spChg>
        <pc:spChg chg="del">
          <ac:chgData name="Manisha Begum Samad" userId="6bf00af3-bd88-4dab-ba84-d805e4686431" providerId="ADAL" clId="{15C6CAC5-A05E-461B-8AFA-DDDBCD9BD9C6}" dt="2025-03-18T10:13:42.913" v="22" actId="478"/>
          <ac:spMkLst>
            <pc:docMk/>
            <pc:sldMk cId="1216019506" sldId="284"/>
            <ac:spMk id="130" creationId="{3613848E-1424-3A1F-B774-00F526ED30B0}"/>
          </ac:spMkLst>
        </pc:spChg>
        <pc:picChg chg="add del mod">
          <ac:chgData name="Manisha Begum Samad" userId="6bf00af3-bd88-4dab-ba84-d805e4686431" providerId="ADAL" clId="{15C6CAC5-A05E-461B-8AFA-DDDBCD9BD9C6}" dt="2025-03-18T10:20:46.429" v="354" actId="21"/>
          <ac:picMkLst>
            <pc:docMk/>
            <pc:sldMk cId="1216019506" sldId="284"/>
            <ac:picMk id="4" creationId="{849EB5A9-D8A0-4AEA-C22D-07B0F32616A7}"/>
          </ac:picMkLst>
        </pc:picChg>
        <pc:picChg chg="del">
          <ac:chgData name="Manisha Begum Samad" userId="6bf00af3-bd88-4dab-ba84-d805e4686431" providerId="ADAL" clId="{15C6CAC5-A05E-461B-8AFA-DDDBCD9BD9C6}" dt="2025-03-18T10:13:34.582" v="19" actId="478"/>
          <ac:picMkLst>
            <pc:docMk/>
            <pc:sldMk cId="1216019506" sldId="284"/>
            <ac:picMk id="5" creationId="{3647285A-77CA-F1EF-5B0C-B81C95035D1B}"/>
          </ac:picMkLst>
        </pc:picChg>
        <pc:picChg chg="del">
          <ac:chgData name="Manisha Begum Samad" userId="6bf00af3-bd88-4dab-ba84-d805e4686431" providerId="ADAL" clId="{15C6CAC5-A05E-461B-8AFA-DDDBCD9BD9C6}" dt="2025-03-18T10:13:34.582" v="19" actId="478"/>
          <ac:picMkLst>
            <pc:docMk/>
            <pc:sldMk cId="1216019506" sldId="284"/>
            <ac:picMk id="7" creationId="{C3C754AE-F5C2-D229-CB5A-8BED83930558}"/>
          </ac:picMkLst>
        </pc:picChg>
        <pc:picChg chg="del">
          <ac:chgData name="Manisha Begum Samad" userId="6bf00af3-bd88-4dab-ba84-d805e4686431" providerId="ADAL" clId="{15C6CAC5-A05E-461B-8AFA-DDDBCD9BD9C6}" dt="2025-03-18T10:13:34.582" v="19" actId="478"/>
          <ac:picMkLst>
            <pc:docMk/>
            <pc:sldMk cId="1216019506" sldId="284"/>
            <ac:picMk id="23" creationId="{040DE0DE-B087-5E47-8F76-EC4A95C7CFE8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140C35-1D80-4137-A97E-8E1AC114505E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859641-7D97-4E26-87D9-A602C842FF1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89357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7FE449-A051-B83B-EA44-2102615723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E042C60-12AA-B879-91C8-86354800761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D137030-E8DE-0EA3-67BA-F24C6EDA7CE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096811-2871-B434-7024-11716C4203F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19CA3D-0CA2-604D-AC6B-DB25A48EEF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2318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89403-A061-0EBB-E21E-5EBFE6F9DB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1817E8-943F-A8E0-9E8A-7294E61370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B33527-AEBC-78A3-5186-C76B2B2E4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2539A0-E058-AA6E-FE78-5AE781931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FF7DDA-3614-00F9-34AD-B425E7ACD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82701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36B88-0151-1A23-46A6-3339C8822B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EF6720-C98D-B24A-7722-CE726147AA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03C0A-87DA-C4E1-4665-C1A8F84D7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1F7E3-D338-CE68-BC4A-E59AED590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B24F5A-3512-178C-566E-D4E3EF21E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4300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CF4052-DBE0-AA48-DB1F-13679E1C86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E46911-6314-A9D7-94A2-C51B570A5F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A9E54D-AE9C-A45C-FA95-465F6AC9D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49813-2E01-5ECB-6C2B-9EB987541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65FBC8-4035-7698-A9D4-8323C85EF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96807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98D77-A4AF-4FA7-C4E5-877ED9113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B39F68-2D10-5BA2-2F28-8102D39BB1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A4A995-C623-64F8-14A7-1184DAA1A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2EA25D-9589-4A61-0D86-7B0593000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C83B82-1435-FCB9-CC83-27D5C9E8F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94750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D5C84-9900-4F89-A756-AABE196CB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C0A180-D72A-795A-4C4E-AECA831AD8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1AE3D6-5871-AF04-5282-F209F8EFE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EBB45-41C9-317D-20D5-165DF3771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B63BA-F319-8144-0910-F0BAC3CF1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85466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E0AA5-575C-3456-F1A4-0A08E8E39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A88229-D2C8-8854-812D-E3F4E15A32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53D178-5938-C20A-DF17-C7382E6CD1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44A4D5-8D09-7882-3BDC-F364A4D45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37F849-8490-6790-BD53-56FB2F73D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1B4BDB-E3C9-917D-E66A-1E045883E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225425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34BE4-0F62-A0E2-24D0-ACEA2F1EA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9707F8-E819-B689-2DB2-5B4C7A6AE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F9BC42-7C25-7920-BDB9-998614A36F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F00B36-280A-95DF-6C83-6029344288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4F8681-0516-105F-01B4-D7AF2749C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C1B009-F9D9-E78F-4447-247461523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A4CA19-10C9-4011-567F-70A2E9BF8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033BBB-8F43-AB85-78EB-A038C5BFD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50770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827C56-B71C-A778-558C-284809A1EB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5C5C424-ACD6-993C-29C7-F449D1E90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8E3E4B-2638-B473-900D-15213EF3E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C9AFBB-AB69-6131-C6BE-02BC1E585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37159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74C2BD-D3AB-0BAB-4398-C1B06BA01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575492-9F61-596D-0736-BB3A548FC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9C75B7-A6E5-6C2D-284F-E3F3ABE69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4825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34F180-E34F-65ED-E38F-522F0681F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C3CD8C-D92C-02CF-9DBE-AD5FEF78D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1F4F33-911D-21EF-C602-6480B541B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D9DD36-3C87-F398-C35A-8C0C52615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E0C7F1-B2FC-8125-451F-8C5E4EB43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F09D36-8403-C055-47EB-543381F89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060497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F14E4-7494-762C-DB53-B4527BBE8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D17270-C47E-B094-7C4F-DC548F41A5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BDC930-6F3E-BDB6-47DA-2C2D98F86E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B48DDB-9C40-2DE3-2195-02F3C08E1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968435-0814-1975-3E8C-1B203C42D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0199E6-E807-F414-B7ED-A3DE14A8D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15619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0F429C-2161-056C-CA5B-C1AD0440A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389412-3A97-0786-3797-2F2CCF5BEE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3FFDA-6EE9-4682-CB63-A3A7DD10FB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B7D30E-C282-4479-BCB1-9E6F6FC60082}" type="datetimeFigureOut">
              <a:rPr lang="en-SE" smtClean="0"/>
              <a:t>2025-03-18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381101-B3F5-3F9C-F172-DF1B4ABD4F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E49E15-58F0-9AA6-749A-A62EC9E48F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8D0294-1796-498C-89B8-67318B45A68E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83415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ti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37B7DA3-0FE6-F316-265D-665D52AE96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9C80B977-1538-A7FE-E222-489E92F36D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1785" y="661583"/>
            <a:ext cx="2598443" cy="252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ACE8FAF-0002-6521-D623-0957CA97561D}"/>
              </a:ext>
            </a:extLst>
          </p:cNvPr>
          <p:cNvSpPr txBox="1"/>
          <p:nvPr/>
        </p:nvSpPr>
        <p:spPr>
          <a:xfrm>
            <a:off x="304808" y="1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ACE75CE-CC5E-3D02-85A4-C7095B57D087}"/>
              </a:ext>
            </a:extLst>
          </p:cNvPr>
          <p:cNvSpPr txBox="1"/>
          <p:nvPr/>
        </p:nvSpPr>
        <p:spPr>
          <a:xfrm>
            <a:off x="4049539" y="291651"/>
            <a:ext cx="1266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Placenta weight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BF6917F-B9F7-2D0F-7605-33A2AE1ED04E}"/>
              </a:ext>
            </a:extLst>
          </p:cNvPr>
          <p:cNvSpPr txBox="1"/>
          <p:nvPr/>
        </p:nvSpPr>
        <p:spPr>
          <a:xfrm>
            <a:off x="1364939" y="280390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Fetus weight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4092EA3-6B66-6854-03A0-13C976FCAA7B}"/>
              </a:ext>
            </a:extLst>
          </p:cNvPr>
          <p:cNvSpPr txBox="1"/>
          <p:nvPr/>
        </p:nvSpPr>
        <p:spPr>
          <a:xfrm>
            <a:off x="6619674" y="291651"/>
            <a:ext cx="1532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Fetus/placenta rati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9A844B-A54C-437C-2A92-984F13382551}"/>
              </a:ext>
            </a:extLst>
          </p:cNvPr>
          <p:cNvSpPr txBox="1"/>
          <p:nvPr/>
        </p:nvSpPr>
        <p:spPr>
          <a:xfrm>
            <a:off x="1378994" y="445359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,b P&lt; 0.0001 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FD2D259-FCD1-F977-F334-A9656B4637E9}"/>
              </a:ext>
            </a:extLst>
          </p:cNvPr>
          <p:cNvSpPr txBox="1"/>
          <p:nvPr/>
        </p:nvSpPr>
        <p:spPr>
          <a:xfrm>
            <a:off x="4034072" y="456620"/>
            <a:ext cx="8739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 P&lt; 0.0001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549E2C9-B157-B993-706A-78119B09EAEC}"/>
              </a:ext>
            </a:extLst>
          </p:cNvPr>
          <p:cNvSpPr txBox="1"/>
          <p:nvPr/>
        </p:nvSpPr>
        <p:spPr>
          <a:xfrm>
            <a:off x="6635753" y="456620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,b P&lt; 0.0001 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08BA5C5-E24D-BD01-DF1A-8AD92BC12B78}"/>
              </a:ext>
            </a:extLst>
          </p:cNvPr>
          <p:cNvSpPr txBox="1"/>
          <p:nvPr/>
        </p:nvSpPr>
        <p:spPr>
          <a:xfrm>
            <a:off x="392924" y="3019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0D41E65-889F-88A7-1D6D-D71D85B351D6}"/>
              </a:ext>
            </a:extLst>
          </p:cNvPr>
          <p:cNvSpPr txBox="1"/>
          <p:nvPr/>
        </p:nvSpPr>
        <p:spPr>
          <a:xfrm>
            <a:off x="3192205" y="29165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66289B0-B269-8107-D5E4-E696C6620448}"/>
              </a:ext>
            </a:extLst>
          </p:cNvPr>
          <p:cNvSpPr txBox="1"/>
          <p:nvPr/>
        </p:nvSpPr>
        <p:spPr>
          <a:xfrm>
            <a:off x="5957175" y="291651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D91F181-150C-5B08-E95B-15658FA85D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1524" y="661583"/>
            <a:ext cx="2941636" cy="2520000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A8A27197-176E-13DA-3C47-DDB9283AAC7A}"/>
              </a:ext>
            </a:extLst>
          </p:cNvPr>
          <p:cNvSpPr txBox="1"/>
          <p:nvPr/>
        </p:nvSpPr>
        <p:spPr>
          <a:xfrm>
            <a:off x="2471158" y="677851"/>
            <a:ext cx="425116" cy="256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  <a:p>
            <a:pPr>
              <a:lnSpc>
                <a:spcPts val="600"/>
              </a:lnSpc>
            </a:pPr>
            <a:r>
              <a:rPr lang="en-SE" sz="1050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8F9AA7F-5FD6-2A20-A8F9-F92FD9B672AC}"/>
              </a:ext>
            </a:extLst>
          </p:cNvPr>
          <p:cNvSpPr txBox="1"/>
          <p:nvPr/>
        </p:nvSpPr>
        <p:spPr>
          <a:xfrm>
            <a:off x="2775055" y="673497"/>
            <a:ext cx="453971" cy="256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  <a:p>
            <a:pPr>
              <a:lnSpc>
                <a:spcPts val="600"/>
              </a:lnSpc>
            </a:pPr>
            <a:r>
              <a:rPr lang="en-SE" sz="1050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D28F26E-97A7-190F-6258-3015B3AA8712}"/>
              </a:ext>
            </a:extLst>
          </p:cNvPr>
          <p:cNvSpPr txBox="1"/>
          <p:nvPr/>
        </p:nvSpPr>
        <p:spPr>
          <a:xfrm>
            <a:off x="4793341" y="703334"/>
            <a:ext cx="263214" cy="1821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284B171-6288-F438-0004-1EC8B7047D22}"/>
              </a:ext>
            </a:extLst>
          </p:cNvPr>
          <p:cNvSpPr txBox="1"/>
          <p:nvPr/>
        </p:nvSpPr>
        <p:spPr>
          <a:xfrm>
            <a:off x="5496488" y="661032"/>
            <a:ext cx="453971" cy="1821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4BE47A4-E8CF-D935-7510-D03BE2DA8BA2}"/>
              </a:ext>
            </a:extLst>
          </p:cNvPr>
          <p:cNvSpPr txBox="1"/>
          <p:nvPr/>
        </p:nvSpPr>
        <p:spPr>
          <a:xfrm>
            <a:off x="7504687" y="831964"/>
            <a:ext cx="263214" cy="1821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786C0BE-DBD7-F6A7-606E-871EBD1CC846}"/>
              </a:ext>
            </a:extLst>
          </p:cNvPr>
          <p:cNvSpPr txBox="1"/>
          <p:nvPr/>
        </p:nvSpPr>
        <p:spPr>
          <a:xfrm>
            <a:off x="7983119" y="967019"/>
            <a:ext cx="453971" cy="259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FDAE94D-2C86-6298-99AA-14846888A87E}"/>
              </a:ext>
            </a:extLst>
          </p:cNvPr>
          <p:cNvSpPr txBox="1"/>
          <p:nvPr/>
        </p:nvSpPr>
        <p:spPr>
          <a:xfrm>
            <a:off x="8243556" y="673496"/>
            <a:ext cx="453971" cy="259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</a:p>
        </p:txBody>
      </p:sp>
      <p:pic>
        <p:nvPicPr>
          <p:cNvPr id="7" name="Picture 6" descr="A group of blue and orange shapes&#10;&#10;AI-generated content may be incorrect.">
            <a:extLst>
              <a:ext uri="{FF2B5EF4-FFF2-40B4-BE49-F238E27FC236}">
                <a16:creationId xmlns:a16="http://schemas.microsoft.com/office/drawing/2014/main" id="{FFC6D7DB-CD40-B287-3591-8F354171DA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4079" y="644825"/>
            <a:ext cx="2908723" cy="252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37BB107-1327-3550-9AA1-7D18EE18B186}"/>
              </a:ext>
            </a:extLst>
          </p:cNvPr>
          <p:cNvSpPr txBox="1"/>
          <p:nvPr/>
        </p:nvSpPr>
        <p:spPr>
          <a:xfrm>
            <a:off x="484079" y="3684743"/>
            <a:ext cx="8989456" cy="13305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 S1. 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fetal weight, and 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placental weight at gestational day (GD) 18.5, 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) Fetus/placenta ratio and D)</a:t>
            </a:r>
            <a:r>
              <a:rPr lang="en-US" sz="1100" b="1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 triglyceride content in fetuses,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APNtg and wt fetuses respectively from APNtg and wt dams on normal chow (NC) and high fat/ high sucrose (HF/HS) diet. </a:t>
            </a:r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n-number/group is included in panel A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effect of diet-induced obesity and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B0400000000000000" pitchFamily="18" charset="-128"/>
                <a:cs typeface="Arial" panose="020B0604020202020204" pitchFamily="34" charset="0"/>
              </a:rPr>
              <a:t>adiponectin overexpression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s analyzed using two-way ANOVA followed by Tukey post hoc test, a; main effect of diet, and b; main effect of dam genotype (wt vs APNtg). *P&lt;0.05, **P&lt;0.005, ***P&lt;0.001 vs wt-wt within diets, # P&lt;0.05, ### P&lt;0.001 vs NC within fetal group a; main effect of diet, b; main effect of genotype.</a:t>
            </a:r>
            <a:endParaRPr lang="en-SE" sz="11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175D21-53AA-1660-C8E1-853F9B226447}"/>
              </a:ext>
            </a:extLst>
          </p:cNvPr>
          <p:cNvSpPr txBox="1"/>
          <p:nvPr/>
        </p:nvSpPr>
        <p:spPr>
          <a:xfrm>
            <a:off x="8726406" y="251706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77E841-D9A2-EE94-5FF5-9318090B1F1A}"/>
              </a:ext>
            </a:extLst>
          </p:cNvPr>
          <p:cNvSpPr txBox="1"/>
          <p:nvPr/>
        </p:nvSpPr>
        <p:spPr>
          <a:xfrm>
            <a:off x="9482032" y="277000"/>
            <a:ext cx="11485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 err="1">
                <a:latin typeface="Arial" panose="020B0604020202020204" pitchFamily="34" charset="0"/>
                <a:cs typeface="Arial" panose="020B0604020202020204" pitchFamily="34" charset="0"/>
              </a:rPr>
              <a:t>Fetu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liver TG</a:t>
            </a:r>
            <a:endParaRPr lang="en-S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AF6D23-8B1F-5F5E-9BD1-3E936FF2E510}"/>
              </a:ext>
            </a:extLst>
          </p:cNvPr>
          <p:cNvSpPr txBox="1"/>
          <p:nvPr/>
        </p:nvSpPr>
        <p:spPr>
          <a:xfrm>
            <a:off x="9482032" y="474929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>
                <a:latin typeface="Arial" panose="020B0604020202020204" pitchFamily="34" charset="0"/>
                <a:cs typeface="Arial" panose="020B0604020202020204" pitchFamily="34" charset="0"/>
              </a:rPr>
              <a:t>b P&lt; 0.0001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49EB5A9-D8A0-4AEA-C22D-07B0F32616A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25859" y="759339"/>
            <a:ext cx="2736000" cy="234384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85FDACD-C13C-D586-C524-AE6B88020192}"/>
              </a:ext>
            </a:extLst>
          </p:cNvPr>
          <p:cNvSpPr txBox="1"/>
          <p:nvPr/>
        </p:nvSpPr>
        <p:spPr>
          <a:xfrm>
            <a:off x="10939015" y="874434"/>
            <a:ext cx="2736000" cy="252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DA3DA6-1852-F7DD-2540-6011144068BB}"/>
              </a:ext>
            </a:extLst>
          </p:cNvPr>
          <p:cNvSpPr txBox="1"/>
          <p:nvPr/>
        </p:nvSpPr>
        <p:spPr>
          <a:xfrm>
            <a:off x="11058013" y="644825"/>
            <a:ext cx="263214" cy="1821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SE" sz="11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F33429-06E2-0165-B08B-D8C7E664B345}"/>
              </a:ext>
            </a:extLst>
          </p:cNvPr>
          <p:cNvSpPr txBox="1"/>
          <p:nvPr/>
        </p:nvSpPr>
        <p:spPr>
          <a:xfrm>
            <a:off x="10781942" y="706963"/>
            <a:ext cx="2736000" cy="252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66002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17</Words>
  <Application>Microsoft Office PowerPoint</Application>
  <PresentationFormat>Widescreen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isha Begum Samad</dc:creator>
  <cp:lastModifiedBy>Manisha Begum Samad</cp:lastModifiedBy>
  <cp:revision>1</cp:revision>
  <dcterms:created xsi:type="dcterms:W3CDTF">2025-03-18T09:54:56Z</dcterms:created>
  <dcterms:modified xsi:type="dcterms:W3CDTF">2025-03-18T10:28:00Z</dcterms:modified>
</cp:coreProperties>
</file>